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93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69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FB9F21-B0EF-5ACC-8F82-8EF01ECC5D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79FD4DF-0092-3B37-F22E-6B90D1FE6A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1DE890-E3E0-4DC7-BE8B-640602B49A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7BC3E-81DD-4FFA-B7AC-F67D23CC61BC}" type="datetimeFigureOut">
              <a:rPr kumimoji="1" lang="ja-JP" altLang="en-US" smtClean="0"/>
              <a:t>2026/2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7EF1164-408E-63B4-BC17-8EF64A386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F8C2331-1AFF-2D74-5999-10CB4922C5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E2387-C678-4F9E-A192-04B973FE86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13430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A02F82-BF53-0D4F-A780-088FD2C59C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7CA6CD5-CC97-0F99-06E7-BF4E29FC96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2E7D4D3-9DB0-70ED-92C1-096E848580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7BC3E-81DD-4FFA-B7AC-F67D23CC61BC}" type="datetimeFigureOut">
              <a:rPr kumimoji="1" lang="ja-JP" altLang="en-US" smtClean="0"/>
              <a:t>2026/2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620149-27C2-94A4-4F5C-8A498E389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45462A2-C0ED-F535-0FF8-3B280B0558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E2387-C678-4F9E-A192-04B973FE86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0538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CDC228E-114E-65B6-3151-A8AE845430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3F21B0D-1A88-63B0-9386-662294119B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C57FD16-7C7C-F972-707A-51BEEED5B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7BC3E-81DD-4FFA-B7AC-F67D23CC61BC}" type="datetimeFigureOut">
              <a:rPr kumimoji="1" lang="ja-JP" altLang="en-US" smtClean="0"/>
              <a:t>2026/2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EA3D77A-4BD9-6D32-5C86-E431FDF25C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D2C1343-6BA3-7500-A2EB-A101F5EFCE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E2387-C678-4F9E-A192-04B973FE86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52546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4FB0E5-FD5E-1431-1F00-E500CAE690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B45B259-220E-1FCD-2E74-3C863AF4A5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64A065B-CE70-A11E-F15A-6A5653881A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7BC3E-81DD-4FFA-B7AC-F67D23CC61BC}" type="datetimeFigureOut">
              <a:rPr kumimoji="1" lang="ja-JP" altLang="en-US" smtClean="0"/>
              <a:t>2026/2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D1F7DFB-7D53-5675-4F8F-F6025D99C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ABA42B1-F571-3C9F-E3ED-1B17393AF7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E2387-C678-4F9E-A192-04B973FE86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5391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9AC67A-C41F-3686-48FB-A6DF118521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D4FEE1B-931E-8AA1-1C14-EB3EC15D88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6AF1D59-B6C3-5610-70CE-3BE00AB750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7BC3E-81DD-4FFA-B7AC-F67D23CC61BC}" type="datetimeFigureOut">
              <a:rPr kumimoji="1" lang="ja-JP" altLang="en-US" smtClean="0"/>
              <a:t>2026/2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9248B0F-9E97-BF32-8721-9590009BE3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E1F6DDB-2CF4-F773-4133-DDA00B82A1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E2387-C678-4F9E-A192-04B973FE86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879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A085BA-8EC5-52E5-705C-8FFF1FCD80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517B20E-ACA1-E0AA-EE51-CE572FA62B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5E9D006-BC62-5AFC-96F0-1DBD16ACA4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49EDE30-BB7F-2FF1-F8FF-AAED4DE9EA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7BC3E-81DD-4FFA-B7AC-F67D23CC61BC}" type="datetimeFigureOut">
              <a:rPr kumimoji="1" lang="ja-JP" altLang="en-US" smtClean="0"/>
              <a:t>2026/2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2FAC70B-ACFF-126E-3FC9-2293B670A3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37A8D55-5667-330B-56CC-6F539D4F0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E2387-C678-4F9E-A192-04B973FE86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16516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C0963C-0058-489E-B71C-1A327591B0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4B48DE8-91FA-93A8-C384-A8771DD3C9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0C996F9-FA97-E8B1-98B7-3886F8047E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DA3A529-06B8-5829-2A72-471FAA4BEC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405B57C-7093-AF65-6FA2-D2888B290C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9A13B1A-79DB-C3F1-FF44-0A77A78AE9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7BC3E-81DD-4FFA-B7AC-F67D23CC61BC}" type="datetimeFigureOut">
              <a:rPr kumimoji="1" lang="ja-JP" altLang="en-US" smtClean="0"/>
              <a:t>2026/2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64174CD-C8F7-7E27-31A1-67F8E4EFB0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8A705CD-D0A5-3C01-768D-C28E9B0BD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E2387-C678-4F9E-A192-04B973FE86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872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1FFF62D-8430-410B-6E72-2534F36361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78751B4-5032-1967-784E-957B7C6427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7BC3E-81DD-4FFA-B7AC-F67D23CC61BC}" type="datetimeFigureOut">
              <a:rPr kumimoji="1" lang="ja-JP" altLang="en-US" smtClean="0"/>
              <a:t>2026/2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765BA89-8F6D-6EA9-66A5-397B7EECB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C1D56B4-6CB2-2EDB-28CE-EB2D25F2C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E2387-C678-4F9E-A192-04B973FE86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7876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AC245A7-9659-0FEE-7A71-EB0BA05816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7BC3E-81DD-4FFA-B7AC-F67D23CC61BC}" type="datetimeFigureOut">
              <a:rPr kumimoji="1" lang="ja-JP" altLang="en-US" smtClean="0"/>
              <a:t>2026/2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DD4482A-023E-C812-3CB2-E5B513E45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3A90C6C-FC05-2FA5-A588-4A5F15F76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E2387-C678-4F9E-A192-04B973FE86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72062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FFB8125-E529-2939-050E-1B494992D7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36B83E4-15E2-DE72-D61F-034B409836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EC58023-2FF9-A55A-843D-3EF8AB924B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C032519-A3CD-17F8-D324-0F2C0575E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7BC3E-81DD-4FFA-B7AC-F67D23CC61BC}" type="datetimeFigureOut">
              <a:rPr kumimoji="1" lang="ja-JP" altLang="en-US" smtClean="0"/>
              <a:t>2026/2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5FCC727-AF65-C4EF-4AB6-E43FE7D64D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719A5F7-203B-E60E-3EE7-904401C0D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E2387-C678-4F9E-A192-04B973FE86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3787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EDE8C7-C7F8-4D05-04D4-A71AA32643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82167BC-2253-4BCB-B3A9-CFA440CA215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C1CE9B0-B5CA-AD71-C900-0CBFE6CD3D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CA7DF5E-81AC-6436-49E8-102268E8AF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7BC3E-81DD-4FFA-B7AC-F67D23CC61BC}" type="datetimeFigureOut">
              <a:rPr kumimoji="1" lang="ja-JP" altLang="en-US" smtClean="0"/>
              <a:t>2026/2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1AD1B86-E1FD-F8C4-CABC-7DAFF5460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DFF2B89-2FAF-D00A-D2D5-11A78DD861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E2387-C678-4F9E-A192-04B973FE86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0523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69D5794-0556-69B6-4451-9D280F61E1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B92ADC2-4D7D-0369-106B-4DD7832030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12BF56-1A52-3767-5254-255FAB47ECF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7C7BC3E-81DD-4FFA-B7AC-F67D23CC61BC}" type="datetimeFigureOut">
              <a:rPr kumimoji="1" lang="ja-JP" altLang="en-US" smtClean="0"/>
              <a:t>2026/2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D50367B-BB7A-BAE1-8F2E-C3E65B3C35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A8EA7ED-58B4-1C03-08EB-16B9A1AEBB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90E2387-C678-4F9E-A192-04B973FE86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18282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40CF013A-2B8A-6EEA-F6D3-39CA0959D4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3900" y="161925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pic>
        <p:nvPicPr>
          <p:cNvPr id="1025" name="図 7">
            <a:extLst>
              <a:ext uri="{FF2B5EF4-FFF2-40B4-BE49-F238E27FC236}">
                <a16:creationId xmlns:a16="http://schemas.microsoft.com/office/drawing/2014/main" id="{888490AF-EA76-B821-F544-F44FF9EED95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5042" y="390525"/>
            <a:ext cx="3614430" cy="35993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AE53F5A2-1189-E045-D786-DD67E4CBA1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632" y="3955124"/>
            <a:ext cx="5983287" cy="25853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en-US" altLang="ja-JP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</a:t>
            </a:r>
            <a:r>
              <a:rPr kumimoji="0" lang="en-US" altLang="ja-JP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kumimoji="0" lang="en-US" altLang="ja-JP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0" lang="en-US" altLang="ja-JP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ceiver operating characteristic (ROC) curves for determining the optimal creatinine/cystatin C ratio (CCR) cutoff value for predicting sarcopenia, low handgrip strength (HGS), and low skeletal muscle index (SMI) in patients with liver cirrhosis who achieved a sustained virological response (SVR) after treatment for hepatitis C virus (HCV) infection.</a:t>
            </a:r>
            <a:endParaRPr kumimoji="0" lang="en-US" altLang="ja-JP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83690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2">
            <a:extLst>
              <a:ext uri="{FF2B5EF4-FFF2-40B4-BE49-F238E27FC236}">
                <a16:creationId xmlns:a16="http://schemas.microsoft.com/office/drawing/2014/main" id="{E232E330-DBAC-C2F6-690A-34E7B7FF78F7}"/>
              </a:ext>
            </a:extLst>
          </p:cNvPr>
          <p:cNvSpPr txBox="1"/>
          <p:nvPr/>
        </p:nvSpPr>
        <p:spPr>
          <a:xfrm>
            <a:off x="267434" y="1258048"/>
            <a:ext cx="9809480" cy="7997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400"/>
              </a:lnSpc>
              <a:buNone/>
            </a:pPr>
            <a:r>
              <a:rPr lang="en-US" sz="9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Table.S1 </a:t>
            </a:r>
            <a:r>
              <a:rPr lang="en-US" sz="800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Diagnostic Performance of the Creatinine-to-Cystatin C Ratio for Sarcopenia and Its Components: Handgrip Strength and Skeletal Muscle Mass Index</a:t>
            </a:r>
          </a:p>
          <a:p>
            <a:pPr algn="just">
              <a:lnSpc>
                <a:spcPts val="1400"/>
              </a:lnSpc>
              <a:buNone/>
            </a:pPr>
            <a:endParaRPr lang="en-US" altLang="ja-JP" sz="800" dirty="0">
              <a:solidFill>
                <a:srgbClr val="000000"/>
              </a:solidFill>
              <a:latin typeface="Palatino Linotype" panose="02040502050505030304" pitchFamily="18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ts val="1400"/>
              </a:lnSpc>
              <a:buNone/>
            </a:pPr>
            <a:endParaRPr lang="en-US" altLang="ja-JP" sz="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ts val="1400"/>
              </a:lnSpc>
              <a:buNone/>
            </a:pPr>
            <a:endParaRPr lang="ja-JP" sz="10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0A353C41-0C0D-77F4-8B4D-8B60C527B5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9893392"/>
              </p:ext>
            </p:extLst>
          </p:nvPr>
        </p:nvGraphicFramePr>
        <p:xfrm>
          <a:off x="496468" y="1657934"/>
          <a:ext cx="6768465" cy="155702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305560">
                  <a:extLst>
                    <a:ext uri="{9D8B030D-6E8A-4147-A177-3AD203B41FA5}">
                      <a16:colId xmlns:a16="http://schemas.microsoft.com/office/drawing/2014/main" val="2668248597"/>
                    </a:ext>
                  </a:extLst>
                </a:gridCol>
                <a:gridCol w="711835">
                  <a:extLst>
                    <a:ext uri="{9D8B030D-6E8A-4147-A177-3AD203B41FA5}">
                      <a16:colId xmlns:a16="http://schemas.microsoft.com/office/drawing/2014/main" val="2281058499"/>
                    </a:ext>
                  </a:extLst>
                </a:gridCol>
                <a:gridCol w="720725">
                  <a:extLst>
                    <a:ext uri="{9D8B030D-6E8A-4147-A177-3AD203B41FA5}">
                      <a16:colId xmlns:a16="http://schemas.microsoft.com/office/drawing/2014/main" val="54788927"/>
                    </a:ext>
                  </a:extLst>
                </a:gridCol>
                <a:gridCol w="720725">
                  <a:extLst>
                    <a:ext uri="{9D8B030D-6E8A-4147-A177-3AD203B41FA5}">
                      <a16:colId xmlns:a16="http://schemas.microsoft.com/office/drawing/2014/main" val="2523194963"/>
                    </a:ext>
                  </a:extLst>
                </a:gridCol>
                <a:gridCol w="494665">
                  <a:extLst>
                    <a:ext uri="{9D8B030D-6E8A-4147-A177-3AD203B41FA5}">
                      <a16:colId xmlns:a16="http://schemas.microsoft.com/office/drawing/2014/main" val="3696258364"/>
                    </a:ext>
                  </a:extLst>
                </a:gridCol>
                <a:gridCol w="405765">
                  <a:extLst>
                    <a:ext uri="{9D8B030D-6E8A-4147-A177-3AD203B41FA5}">
                      <a16:colId xmlns:a16="http://schemas.microsoft.com/office/drawing/2014/main" val="1717784291"/>
                    </a:ext>
                  </a:extLst>
                </a:gridCol>
                <a:gridCol w="459105">
                  <a:extLst>
                    <a:ext uri="{9D8B030D-6E8A-4147-A177-3AD203B41FA5}">
                      <a16:colId xmlns:a16="http://schemas.microsoft.com/office/drawing/2014/main" val="4285905538"/>
                    </a:ext>
                  </a:extLst>
                </a:gridCol>
                <a:gridCol w="1357630">
                  <a:extLst>
                    <a:ext uri="{9D8B030D-6E8A-4147-A177-3AD203B41FA5}">
                      <a16:colId xmlns:a16="http://schemas.microsoft.com/office/drawing/2014/main" val="2573286080"/>
                    </a:ext>
                  </a:extLst>
                </a:gridCol>
                <a:gridCol w="592455">
                  <a:extLst>
                    <a:ext uri="{9D8B030D-6E8A-4147-A177-3AD203B41FA5}">
                      <a16:colId xmlns:a16="http://schemas.microsoft.com/office/drawing/2014/main" val="683571210"/>
                    </a:ext>
                  </a:extLst>
                </a:gridCol>
              </a:tblGrid>
              <a:tr h="361950"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de-DE" sz="1050" kern="1200" dirty="0">
                          <a:effectLst/>
                          <a:latin typeface="Palatino Linotype" panose="02040502050505030304" pitchFamily="18" charset="0"/>
                        </a:rPr>
                        <a:t>Diagnostic model</a:t>
                      </a:r>
                      <a:endParaRPr lang="ja-JP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 dirty="0">
                          <a:effectLst/>
                          <a:latin typeface="Palatino Linotype" panose="02040502050505030304" pitchFamily="18" charset="0"/>
                        </a:rPr>
                        <a:t>Threshold</a:t>
                      </a:r>
                      <a:endParaRPr lang="ja-JP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 dirty="0">
                          <a:effectLst/>
                          <a:latin typeface="Palatino Linotype" panose="02040502050505030304" pitchFamily="18" charset="0"/>
                        </a:rPr>
                        <a:t>S</a:t>
                      </a:r>
                      <a:r>
                        <a:rPr lang="de-DE" sz="1050" kern="1200" dirty="0">
                          <a:effectLst/>
                          <a:latin typeface="Palatino Linotype" panose="02040502050505030304" pitchFamily="18" charset="0"/>
                        </a:rPr>
                        <a:t>ensitivity</a:t>
                      </a:r>
                      <a:endParaRPr lang="ja-JP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 dirty="0">
                          <a:effectLst/>
                          <a:latin typeface="Palatino Linotype" panose="02040502050505030304" pitchFamily="18" charset="0"/>
                        </a:rPr>
                        <a:t>S</a:t>
                      </a:r>
                      <a:r>
                        <a:rPr lang="de-DE" sz="1050" kern="1200" dirty="0">
                          <a:effectLst/>
                          <a:latin typeface="Palatino Linotype" panose="02040502050505030304" pitchFamily="18" charset="0"/>
                        </a:rPr>
                        <a:t>pecifivity</a:t>
                      </a:r>
                      <a:endParaRPr lang="ja-JP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de-DE" sz="1050" kern="1200" dirty="0">
                          <a:effectLst/>
                          <a:latin typeface="Palatino Linotype" panose="02040502050505030304" pitchFamily="18" charset="0"/>
                        </a:rPr>
                        <a:t>PPV</a:t>
                      </a:r>
                      <a:endParaRPr lang="ja-JP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de-DE" sz="1050" kern="1200">
                          <a:effectLst/>
                          <a:latin typeface="Palatino Linotype" panose="02040502050505030304" pitchFamily="18" charset="0"/>
                        </a:rPr>
                        <a:t>NPV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de-DE" sz="1050" kern="1200" dirty="0">
                          <a:effectLst/>
                          <a:latin typeface="Palatino Linotype" panose="02040502050505030304" pitchFamily="18" charset="0"/>
                        </a:rPr>
                        <a:t>AIC</a:t>
                      </a:r>
                      <a:endParaRPr lang="ja-JP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de-DE" sz="1050" kern="1200" dirty="0">
                          <a:effectLst/>
                          <a:latin typeface="Palatino Linotype" panose="02040502050505030304" pitchFamily="18" charset="0"/>
                        </a:rPr>
                        <a:t>AUC </a:t>
                      </a:r>
                      <a:r>
                        <a:rPr lang="en-US" sz="1050" kern="1200" dirty="0">
                          <a:effectLst/>
                          <a:latin typeface="Palatino Linotype" panose="02040502050505030304" pitchFamily="18" charset="0"/>
                        </a:rPr>
                        <a:t>(</a:t>
                      </a:r>
                      <a:r>
                        <a:rPr lang="de-DE" sz="1050" kern="1200" dirty="0">
                          <a:effectLst/>
                          <a:latin typeface="Palatino Linotype" panose="02040502050505030304" pitchFamily="18" charset="0"/>
                        </a:rPr>
                        <a:t>95% IC</a:t>
                      </a:r>
                      <a:r>
                        <a:rPr lang="en-US" sz="1050" kern="1200" dirty="0"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ja-JP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 dirty="0">
                          <a:effectLst/>
                          <a:latin typeface="Palatino Linotype" panose="02040502050505030304" pitchFamily="18" charset="0"/>
                        </a:rPr>
                        <a:t>P value </a:t>
                      </a:r>
                      <a:endParaRPr lang="ja-JP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9990348"/>
                  </a:ext>
                </a:extLst>
              </a:tr>
              <a:tr h="361950"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de-DE" sz="1050" kern="1200">
                          <a:effectLst/>
                          <a:latin typeface="Palatino Linotype" panose="02040502050505030304" pitchFamily="18" charset="0"/>
                        </a:rPr>
                        <a:t>sarcopenia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0.561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0.767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0.790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0.575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0.902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104.2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0.824 (0.734 - 0.91)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958136124"/>
                  </a:ext>
                </a:extLst>
              </a:tr>
              <a:tr h="471170"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de-DE" sz="1050" kern="1200">
                          <a:effectLst/>
                          <a:latin typeface="Palatino Linotype" panose="02040502050505030304" pitchFamily="18" charset="0"/>
                        </a:rPr>
                        <a:t>low handgrip strength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0.582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0.717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 dirty="0">
                          <a:effectLst/>
                          <a:latin typeface="Palatino Linotype" panose="02040502050505030304" pitchFamily="18" charset="0"/>
                        </a:rPr>
                        <a:t>0.769</a:t>
                      </a:r>
                      <a:endParaRPr lang="ja-JP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 0.687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0.793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126.9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0.790 (0.704 - 0.877) 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0.587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240476475"/>
                  </a:ext>
                </a:extLst>
              </a:tr>
              <a:tr h="361950"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de-DE" sz="1050" kern="1200" dirty="0">
                          <a:effectLst/>
                          <a:latin typeface="Palatino Linotype" panose="02040502050505030304" pitchFamily="18" charset="0"/>
                        </a:rPr>
                        <a:t>low skeletal mass index</a:t>
                      </a:r>
                      <a:endParaRPr lang="ja-JP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 dirty="0">
                          <a:effectLst/>
                          <a:latin typeface="Palatino Linotype" panose="02040502050505030304" pitchFamily="18" charset="0"/>
                        </a:rPr>
                        <a:t>0.581</a:t>
                      </a:r>
                      <a:endParaRPr lang="ja-JP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0.690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0.739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 0.617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 dirty="0">
                          <a:effectLst/>
                          <a:latin typeface="Palatino Linotype" panose="02040502050505030304" pitchFamily="18" charset="0"/>
                        </a:rPr>
                        <a:t>0.797</a:t>
                      </a:r>
                      <a:endParaRPr lang="ja-JP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>
                          <a:effectLst/>
                          <a:latin typeface="Palatino Linotype" panose="02040502050505030304" pitchFamily="18" charset="0"/>
                        </a:rPr>
                        <a:t>131.7</a:t>
                      </a:r>
                      <a:endParaRPr lang="ja-JP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 dirty="0">
                          <a:effectLst/>
                          <a:latin typeface="Palatino Linotype" panose="02040502050505030304" pitchFamily="18" charset="0"/>
                        </a:rPr>
                        <a:t>0.761 (0.668 - 0.855) </a:t>
                      </a:r>
                      <a:endParaRPr lang="ja-JP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400"/>
                        </a:lnSpc>
                        <a:buNone/>
                      </a:pPr>
                      <a:r>
                        <a:rPr lang="en-US" sz="1050" kern="1200" dirty="0">
                          <a:effectLst/>
                          <a:latin typeface="Palatino Linotype" panose="02040502050505030304" pitchFamily="18" charset="0"/>
                        </a:rPr>
                        <a:t>0.324</a:t>
                      </a:r>
                      <a:endParaRPr lang="ja-JP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596739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072427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59</Words>
  <Application>Microsoft Office PowerPoint</Application>
  <PresentationFormat>ワイド画面</PresentationFormat>
  <Paragraphs>4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Palatino Linotype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正 浪崎</dc:creator>
  <cp:lastModifiedBy>正 浪崎</cp:lastModifiedBy>
  <cp:revision>1</cp:revision>
  <dcterms:created xsi:type="dcterms:W3CDTF">2026-02-12T13:39:00Z</dcterms:created>
  <dcterms:modified xsi:type="dcterms:W3CDTF">2026-02-12T13:41:12Z</dcterms:modified>
</cp:coreProperties>
</file>